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9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8" autoAdjust="0"/>
    <p:restoredTop sz="94660"/>
  </p:normalViewPr>
  <p:slideViewPr>
    <p:cSldViewPr snapToGrid="0">
      <p:cViewPr varScale="1">
        <p:scale>
          <a:sx n="83" d="100"/>
          <a:sy n="83" d="100"/>
        </p:scale>
        <p:origin x="124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C97DC-1ADD-4AB1-8D45-8506D08D4C63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8D2A85-1D42-4502-A1AB-E72A90204C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74640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5E5E62-4A3A-60BF-6CFA-3FED269CAEE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7D381B48-CFE6-42A5-2B62-B5F92644355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413D300F-C9F7-C683-6C5B-1996BFB9948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1B709A7-5E4C-9C72-B779-535D56A8F4F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45B2B6-7AB1-7444-9F17-11A822F2364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816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1738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5322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0749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09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4147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2880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8748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7655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751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3328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292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28F95-4B0B-42FB-852A-9963028AB819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64EDF-EBD0-4141-A9AC-B95E7A5D7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4233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3769089-29B8-419D-1C8E-D285AB593C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EF6DD571-64DF-E2E8-846C-2B8C962E7B96}"/>
              </a:ext>
            </a:extLst>
          </p:cNvPr>
          <p:cNvGrpSpPr/>
          <p:nvPr/>
        </p:nvGrpSpPr>
        <p:grpSpPr>
          <a:xfrm>
            <a:off x="211747" y="829851"/>
            <a:ext cx="6016270" cy="1021846"/>
            <a:chOff x="158855" y="709530"/>
            <a:chExt cx="6016270" cy="1021846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3474102D-8950-E2AB-3847-F17C332352D3}"/>
                </a:ext>
              </a:extLst>
            </p:cNvPr>
            <p:cNvSpPr txBox="1"/>
            <p:nvPr/>
          </p:nvSpPr>
          <p:spPr>
            <a:xfrm>
              <a:off x="1754909" y="858982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ja-JP" altLang="en-US" dirty="0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21310B94-ECFE-7719-24C0-7F30D8B52081}"/>
                </a:ext>
              </a:extLst>
            </p:cNvPr>
            <p:cNvSpPr/>
            <p:nvPr/>
          </p:nvSpPr>
          <p:spPr>
            <a:xfrm>
              <a:off x="158855" y="715713"/>
              <a:ext cx="910560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1</a:t>
              </a:r>
            </a:p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2</a:t>
              </a:r>
            </a:p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3</a:t>
              </a:r>
            </a:p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4</a:t>
              </a:r>
            </a:p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5</a:t>
              </a: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9F3B9C1F-33DE-D83B-1417-8DA4772221C2}"/>
                </a:ext>
              </a:extLst>
            </p:cNvPr>
            <p:cNvSpPr/>
            <p:nvPr/>
          </p:nvSpPr>
          <p:spPr>
            <a:xfrm>
              <a:off x="2017829" y="709530"/>
              <a:ext cx="770332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gt; 95 %</a:t>
              </a:r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&gt; 95 %</a:t>
              </a:r>
            </a:p>
            <a:p>
              <a:pPr algn="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%</a:t>
              </a:r>
            </a:p>
            <a:p>
              <a:pPr algn="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%</a:t>
              </a:r>
            </a:p>
            <a:p>
              <a:pPr algn="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0 %</a:t>
              </a: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B0F0CA85-552A-1F5F-75E7-04EB06191971}"/>
                </a:ext>
              </a:extLst>
            </p:cNvPr>
            <p:cNvSpPr/>
            <p:nvPr/>
          </p:nvSpPr>
          <p:spPr>
            <a:xfrm>
              <a:off x="2965054" y="709530"/>
              <a:ext cx="701750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gt; 95 % </a:t>
              </a:r>
              <a:b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0 %</a:t>
              </a:r>
              <a:b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%</a:t>
              </a:r>
              <a:b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%</a:t>
              </a:r>
              <a:b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0 %</a:t>
              </a:r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4C160692-DAD2-51B4-E6F1-F0A919769EB3}"/>
                </a:ext>
              </a:extLst>
            </p:cNvPr>
            <p:cNvSpPr/>
            <p:nvPr/>
          </p:nvSpPr>
          <p:spPr>
            <a:xfrm>
              <a:off x="4122505" y="709530"/>
              <a:ext cx="672521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+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+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+</a:t>
              </a: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2C918142-EE65-CC7F-CAD5-B43FB7CCBC58}"/>
                </a:ext>
              </a:extLst>
            </p:cNvPr>
            <p:cNvSpPr/>
            <p:nvPr/>
          </p:nvSpPr>
          <p:spPr>
            <a:xfrm>
              <a:off x="5264565" y="709530"/>
              <a:ext cx="910560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ー</a:t>
              </a:r>
              <a:endPara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e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e </a:t>
              </a:r>
            </a:p>
            <a:p>
              <a:pPr algn="ctr"/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ー</a:t>
              </a:r>
              <a:endPara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e</a:t>
              </a: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063ADA81-119A-F8C2-0C45-4CF873254268}"/>
                </a:ext>
              </a:extLst>
            </p:cNvPr>
            <p:cNvSpPr/>
            <p:nvPr/>
          </p:nvSpPr>
          <p:spPr>
            <a:xfrm>
              <a:off x="694134" y="709530"/>
              <a:ext cx="1661964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DC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DC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DC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plastic carcinoma</a:t>
              </a:r>
            </a:p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DC</a:t>
              </a:r>
            </a:p>
          </p:txBody>
        </p:sp>
      </p:grp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61D1706-506D-8485-0277-17A60A9A19C0}"/>
              </a:ext>
            </a:extLst>
          </p:cNvPr>
          <p:cNvSpPr txBox="1"/>
          <p:nvPr/>
        </p:nvSpPr>
        <p:spPr>
          <a:xfrm>
            <a:off x="170296" y="537250"/>
            <a:ext cx="88982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ID         </a:t>
            </a:r>
            <a:r>
              <a:rPr kumimoji="1" lang="en-US" altLang="ja-JP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otology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ER Status      </a:t>
            </a:r>
            <a:r>
              <a:rPr kumimoji="1" lang="en-US" altLang="ja-JP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R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us      HER2 IHC Status  </a:t>
            </a:r>
            <a:r>
              <a:rPr kumimoji="1"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R2 FISH Status      MIB-1 Index       Tumor Size(mm)                                                               </a:t>
            </a: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4E68D89B-F285-084C-9BE7-3B9663BEE590}"/>
              </a:ext>
            </a:extLst>
          </p:cNvPr>
          <p:cNvCxnSpPr>
            <a:cxnSpLocks/>
          </p:cNvCxnSpPr>
          <p:nvPr/>
        </p:nvCxnSpPr>
        <p:spPr>
          <a:xfrm>
            <a:off x="150022" y="808941"/>
            <a:ext cx="872384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4CE1164A-16E4-43C1-F39D-53648C24A336}"/>
              </a:ext>
            </a:extLst>
          </p:cNvPr>
          <p:cNvCxnSpPr>
            <a:cxnSpLocks/>
          </p:cNvCxnSpPr>
          <p:nvPr/>
        </p:nvCxnSpPr>
        <p:spPr>
          <a:xfrm>
            <a:off x="150022" y="539739"/>
            <a:ext cx="872384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ED3A1378-ED36-45C1-E14D-2C95A2543DF1}"/>
              </a:ext>
            </a:extLst>
          </p:cNvPr>
          <p:cNvCxnSpPr>
            <a:cxnSpLocks/>
          </p:cNvCxnSpPr>
          <p:nvPr/>
        </p:nvCxnSpPr>
        <p:spPr>
          <a:xfrm flipV="1">
            <a:off x="150022" y="1872960"/>
            <a:ext cx="8723842" cy="1505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74EA698-AAD2-D741-054B-EF38EAE22E1F}"/>
              </a:ext>
            </a:extLst>
          </p:cNvPr>
          <p:cNvSpPr txBox="1"/>
          <p:nvPr/>
        </p:nvSpPr>
        <p:spPr>
          <a:xfrm>
            <a:off x="211747" y="215961"/>
            <a:ext cx="6306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1.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hological characteristics of the breast cancer patient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AB0E2DE6-86E6-BC9B-0042-347A5403DDA1}"/>
              </a:ext>
            </a:extLst>
          </p:cNvPr>
          <p:cNvSpPr/>
          <p:nvPr/>
        </p:nvSpPr>
        <p:spPr>
          <a:xfrm>
            <a:off x="6535660" y="836034"/>
            <a:ext cx="88119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% 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%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 %    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%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%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D462F1B-4196-EB62-9ECB-62B7825E5F00}"/>
              </a:ext>
            </a:extLst>
          </p:cNvPr>
          <p:cNvSpPr txBox="1"/>
          <p:nvPr/>
        </p:nvSpPr>
        <p:spPr>
          <a:xfrm>
            <a:off x="150022" y="1919489"/>
            <a:ext cx="74896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C; Invasive ductal carcinoma, ER; Estrogen Receptor,  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R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rogesterone receptor,  IHC;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hisotochemistry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b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SH; fluorescence in situ hybridization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3E8A6B98-7B5D-5D85-5E23-CE7F6FC3D9C2}"/>
              </a:ext>
            </a:extLst>
          </p:cNvPr>
          <p:cNvCxnSpPr>
            <a:cxnSpLocks/>
          </p:cNvCxnSpPr>
          <p:nvPr/>
        </p:nvCxnSpPr>
        <p:spPr>
          <a:xfrm flipV="1">
            <a:off x="150022" y="2373624"/>
            <a:ext cx="8723842" cy="1505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8BFE7E66-3F8E-4E02-10CB-CDBC62F0FFCC}"/>
              </a:ext>
            </a:extLst>
          </p:cNvPr>
          <p:cNvSpPr/>
          <p:nvPr/>
        </p:nvSpPr>
        <p:spPr>
          <a:xfrm>
            <a:off x="7640521" y="836034"/>
            <a:ext cx="88119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 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  <a:p>
            <a:pPr algn="ctr"/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ー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</a:p>
        </p:txBody>
      </p:sp>
    </p:spTree>
    <p:extLst>
      <p:ext uri="{BB962C8B-B14F-4D97-AF65-F5344CB8AC3E}">
        <p14:creationId xmlns:p14="http://schemas.microsoft.com/office/powerpoint/2010/main" val="2828595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6</TotalTime>
  <Words>127</Words>
  <Application>Microsoft Office PowerPoint</Application>
  <PresentationFormat>On-screen Show (4:3)</PresentationFormat>
  <Paragraphs>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崎 隆史</dc:creator>
  <cp:lastModifiedBy>MDPI</cp:lastModifiedBy>
  <cp:revision>25</cp:revision>
  <dcterms:created xsi:type="dcterms:W3CDTF">2020-11-16T10:41:44Z</dcterms:created>
  <dcterms:modified xsi:type="dcterms:W3CDTF">2024-12-16T12:26:48Z</dcterms:modified>
</cp:coreProperties>
</file>